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85" d="100"/>
          <a:sy n="85" d="100"/>
        </p:scale>
        <p:origin x="-1170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/>
        </p:nvGraphicFramePr>
        <p:xfrm>
          <a:off x="2198097" y="928670"/>
          <a:ext cx="5660061" cy="4765525"/>
        </p:xfrm>
        <a:graphic>
          <a:graphicData uri="http://schemas.openxmlformats.org/drawingml/2006/table">
            <a:tbl>
              <a:tblPr/>
              <a:tblGrid>
                <a:gridCol w="427686"/>
                <a:gridCol w="209295"/>
                <a:gridCol w="209295"/>
                <a:gridCol w="209295"/>
                <a:gridCol w="209295"/>
                <a:gridCol w="209295"/>
                <a:gridCol w="209295"/>
                <a:gridCol w="209295"/>
                <a:gridCol w="209295"/>
                <a:gridCol w="209295"/>
                <a:gridCol w="209295"/>
                <a:gridCol w="209295"/>
                <a:gridCol w="209295"/>
                <a:gridCol w="209295"/>
                <a:gridCol w="209295"/>
                <a:gridCol w="209295"/>
                <a:gridCol w="209295"/>
                <a:gridCol w="209295"/>
                <a:gridCol w="209295"/>
                <a:gridCol w="209295"/>
                <a:gridCol w="209295"/>
                <a:gridCol w="209295"/>
                <a:gridCol w="209295"/>
                <a:gridCol w="209295"/>
                <a:gridCol w="209295"/>
                <a:gridCol w="209295"/>
              </a:tblGrid>
              <a:tr h="189866">
                <a:tc>
                  <a:txBody>
                    <a:bodyPr/>
                    <a:lstStyle/>
                    <a:p>
                      <a:pPr algn="ctr" fontAlgn="ctr"/>
                      <a:endParaRPr lang="zh-CN" altLang="en-US" sz="12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741" marR="7741" marT="77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8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3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7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9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5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6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2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4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7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8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0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1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2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3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9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1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4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5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986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1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986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2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986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3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986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4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986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5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986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6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986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7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986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8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986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9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986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10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986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11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986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12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986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13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986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14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986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15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986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16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986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17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986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18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986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19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986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20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986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21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986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22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986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23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986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24</a:t>
                      </a:r>
                    </a:p>
                  </a:txBody>
                  <a:tcPr marL="7741" marR="7741" marT="774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7741" marR="7741" marT="774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 rot="10800000">
            <a:off x="1752881" y="1391411"/>
            <a:ext cx="461665" cy="3894977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Orange-spotted grouper linkage group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911646" y="559338"/>
            <a:ext cx="25465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Zebrafish chromosomes</a:t>
            </a:r>
            <a:endParaRPr lang="zh-CN" altLang="en-US" b="1" dirty="0" smtClean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8</Words>
  <PresentationFormat>全屏显示(4:3)</PresentationFormat>
  <Paragraphs>65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cp:lastModifiedBy>dell</cp:lastModifiedBy>
  <cp:revision>1</cp:revision>
  <dcterms:modified xsi:type="dcterms:W3CDTF">2013-06-21T14:37:19Z</dcterms:modified>
</cp:coreProperties>
</file>